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F9C580-35F0-45A4-8F81-D0C467A0288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6C69AF-0663-4000-8A9F-A33044D376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95065-22A9-46E2-A73C-63E289229F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38E7E-7EEC-43C2-A69D-E5ABBADE56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504759-84EF-46F2-BA59-B4073F0F97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94F00C-841C-4A4C-9865-EF688128FD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90BC4-8BB4-41C1-8212-AC4F78B04A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4F3DAA-EFA2-44A2-B5EE-4870C1AFAA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A7386-CEDE-4828-8C6D-DBB57F0589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4DA70-33F9-4CA2-BC77-564A3A67C7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9064A-2D42-48E4-9370-D30B30B223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A5B12-9027-45A2-AAB8-C530E9636D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7B0F23-0D07-4082-9334-B73EBBFC8F00}" type="slidenum">
              <a:rPr b="0" lang="sv-S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1476360" y="765000"/>
            <a:ext cx="6524640" cy="522792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5"/>
          <p:cNvSpPr/>
          <p:nvPr/>
        </p:nvSpPr>
        <p:spPr>
          <a:xfrm>
            <a:off x="0" y="0"/>
            <a:ext cx="6046920" cy="72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2800" spc="-1" strike="noStrike">
                <a:solidFill>
                  <a:srgbClr val="000000"/>
                </a:solidFill>
                <a:latin typeface="Arial"/>
              </a:rPr>
              <a:t>Figure 2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"/>
          <p:cNvSpPr/>
          <p:nvPr/>
        </p:nvSpPr>
        <p:spPr>
          <a:xfrm>
            <a:off x="2987640" y="4797360"/>
            <a:ext cx="23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Milk production for the first chil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3276720" y="5013360"/>
            <a:ext cx="17287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Log-Rank P</a:t>
            </a:r>
            <a:r>
              <a:rPr b="0" lang="sv-SE" sz="1200" spc="-1" strike="noStrike" baseline="-25000">
                <a:solidFill>
                  <a:srgbClr val="000000"/>
                </a:solidFill>
                <a:latin typeface="Arial"/>
              </a:rPr>
              <a:t>trend</a:t>
            </a: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=0.0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5364000" y="1341360"/>
            <a:ext cx="100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most no mil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>
            <a:off x="5580000" y="1628640"/>
            <a:ext cx="86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suffici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"/>
          <p:cNvSpPr/>
          <p:nvPr/>
        </p:nvSpPr>
        <p:spPr>
          <a:xfrm>
            <a:off x="5651640" y="227664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dequ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"/>
          <p:cNvSpPr/>
          <p:nvPr/>
        </p:nvSpPr>
        <p:spPr>
          <a:xfrm>
            <a:off x="5580000" y="2708280"/>
            <a:ext cx="79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cess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ruta 2"/>
          <p:cNvSpPr/>
          <p:nvPr/>
        </p:nvSpPr>
        <p:spPr>
          <a:xfrm>
            <a:off x="1332000" y="5805360"/>
            <a:ext cx="575928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7160" bIns="471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5f5f5f"/>
                </a:solidFill>
                <a:latin typeface="Arial"/>
                <a:ea typeface="Arial"/>
              </a:rPr>
              <a:t>Almost no n=   23         23        23        21         13        12        8            8        3         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sufficient n=  127      121      114       96         58        47        26         19       2         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000" spc="-1" strike="noStrike">
                <a:solidFill>
                  <a:srgbClr val="5f5f5f"/>
                </a:solidFill>
                <a:latin typeface="Arial"/>
                <a:ea typeface="Arial"/>
              </a:rPr>
              <a:t>Adequate n=    242      236      221       199       151      125      73          57      14        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000" spc="-1" strike="noStrike">
                <a:solidFill>
                  <a:srgbClr val="000000"/>
                </a:solidFill>
                <a:latin typeface="Arial"/>
                <a:ea typeface="Arial"/>
              </a:rPr>
              <a:t>Excessive n=    78        77        66         50         35        30       12          8        2         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ruta 2"/>
          <p:cNvSpPr/>
          <p:nvPr/>
        </p:nvSpPr>
        <p:spPr>
          <a:xfrm>
            <a:off x="6659640" y="5661000"/>
            <a:ext cx="934920" cy="85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7160" bIns="471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o of even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5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000" spc="-1" strike="noStrike">
                <a:solidFill>
                  <a:srgbClr val="000000"/>
                </a:solidFill>
                <a:latin typeface="Arial"/>
                <a:ea typeface="Arial"/>
              </a:rPr>
              <a:t>27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000" spc="-1" strike="noStrike">
                <a:solidFill>
                  <a:srgbClr val="000000"/>
                </a:solidFill>
                <a:latin typeface="Arial"/>
                <a:ea typeface="Arial"/>
              </a:rPr>
              <a:t>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7T14:10:52Z</dcterms:created>
  <dc:creator>OFALSTUD</dc:creator>
  <dc:description/>
  <dc:language>en-US</dc:language>
  <cp:lastModifiedBy>Helena Jernström</cp:lastModifiedBy>
  <dcterms:modified xsi:type="dcterms:W3CDTF">2013-06-19T07:19:22Z</dcterms:modified>
  <cp:revision>8</cp:revision>
  <dc:subject/>
  <dc:title>Figure 1a</dc:title>
</cp:coreProperties>
</file>